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28AF7D-8196-49EE-A989-AEF7B4418B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E99FDA1-49D8-4E2E-9F76-955393CD52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0C7587-6E4B-4543-8ED8-527CD9ECE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BCADAF-90B7-4018-9DB6-AEC1CEC65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8E6E00-AF63-4564-8240-038F46F97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1403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AB6729-599B-4DB8-BAC9-4D13031FEF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824EAFE-B7ED-447A-AD98-ADFB8A420F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F24EFD-EFD2-4C35-B3FB-8A3C98B43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0BBD3E-4580-4C94-9E58-4DAE15815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DFBABE-775B-40FF-B780-3894BDBB6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164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056D28A-0861-42CF-86BE-AC5E9266F6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43B8A96-E64A-40D5-BCB3-C03517C14B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7B6B29-9ABF-4B8F-9EDB-7B26E1366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54A926-1AAE-4BEF-B97D-EA1E48766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DEA23A-AAAC-44CE-AB5B-EF8715DA7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624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C8D5CE-AE81-42D1-8EF7-69D07E1FF3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D39B667-0C9F-48F1-A6E2-ADD7AD0FF4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5B09E5-E71D-4F92-96DB-70969CF3D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C29C4F-68CD-46D6-A2BA-53162C81B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9D3F41-BF38-4090-B43D-C73FE12D5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7498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BCFDA7-6A49-4330-9DD1-0FCBD09301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FDD2382-8659-4BDA-BE29-105C8E8AF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48E9BB-E593-4325-855A-2625D4417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B025BC-DD9C-4BBA-BA8D-8AEBADD96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C365CD-0FC5-4631-9C7C-44889D2BD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082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E878D1-FA85-4662-8066-1755F525BE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F0C400C-03E7-4A33-ABF7-9538E43877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B0E2DF9-7138-43AD-8C86-7B8F0012BF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DF4402-D8E3-4B04-8063-51E64DF1A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46C4B0-029B-4D89-802E-B41A253A7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FE567E-4A2C-4BD2-86DA-8A8523F6C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7306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ED3CEE-9A6B-4A6A-AD81-2073D2284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A5629FC-707F-4EC0-999C-524B469596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A5BEB5C-CD4D-49FB-8E04-46AD42B6F6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BEC7393-8BF9-4324-AA9D-2E7B3AB5DB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CC064DE-8B59-4D23-84A3-12911EC115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F68CAC9-BDB1-4D08-AEA4-8E24359F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884F883-78A5-4B13-81E5-217C76E86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B846637-7C5E-4206-B347-022E2DE72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684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5BB117-2FBF-4F9C-A120-73EC49722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02077BF-5E6F-43B4-8593-F4559650C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4B9E79D-E24B-4329-BD9C-460DB77C2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8E68533-13C3-4BDE-9747-DF864E0C6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548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1E04464-1CD9-4ADA-ADDC-D83344960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AFA19CC-315A-4680-8F4F-1221E9D08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BEE6B43-5F37-4AB1-A6D9-E14491CCF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438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7EC805-4B3B-4690-95DD-9A45A2802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7B70D9C-037F-41EA-B16A-0FCA24157D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1DB897C-1DB2-4756-9301-B136F39A41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ED587FC-D631-448E-B56D-ADBED79C6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81B1B11-B17D-44A9-AE9A-619194EA5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2DE1865-0662-4A16-A32F-EAD7BA367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73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A4019F-1D5D-42F1-86F2-E620E29515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C7C5710-9601-4463-B846-671DB8242C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BF6088A-1F16-4808-B168-B79296A80F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49AB11C-7586-4205-9DF2-541B4D2B1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7AEEEC0-F129-4612-8C80-DA430DE73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2EBF3CE-762E-4787-A2E3-A76BC4C6A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257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1BB814E-27E8-4519-800C-F69E215C07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3889680-8215-4391-939E-794C4479FA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1D43609-5629-457E-A0DA-FD99BDBDD4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5DD1BB-ADC8-40A3-9D75-5B2FF27850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43F5C0-BECA-4B11-B7CE-257B72397A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437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8E9274D-4CDC-4E52-96F7-EA686A527C16}"/>
              </a:ext>
            </a:extLst>
          </p:cNvPr>
          <p:cNvSpPr txBox="1"/>
          <p:nvPr/>
        </p:nvSpPr>
        <p:spPr>
          <a:xfrm>
            <a:off x="0" y="0"/>
            <a:ext cx="35285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ull length blots in Figure 3</a:t>
            </a:r>
            <a:endParaRPr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EA718260-91A2-4BEA-8F6E-B5869E479AE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6350" y="882133"/>
            <a:ext cx="3719322" cy="1746504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2BAAA3C-1CB5-4BCA-8E58-4CB2B0BC9B7D}"/>
              </a:ext>
            </a:extLst>
          </p:cNvPr>
          <p:cNvSpPr txBox="1"/>
          <p:nvPr/>
        </p:nvSpPr>
        <p:spPr>
          <a:xfrm>
            <a:off x="249730" y="532257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PN1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A67C3A8C-B7BD-4F2F-8D35-F944541DC3F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869049" y="839243"/>
            <a:ext cx="3572256" cy="2164080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AF90D07-949D-43C0-BEB4-AAF702CE33B8}"/>
              </a:ext>
            </a:extLst>
          </p:cNvPr>
          <p:cNvSpPr txBox="1"/>
          <p:nvPr/>
        </p:nvSpPr>
        <p:spPr>
          <a:xfrm>
            <a:off x="7869049" y="489367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119E4287-D84F-40D9-98C3-AB35CFAF7DA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90024" y="882133"/>
            <a:ext cx="3344418" cy="1623060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D1AA51F-6324-40FE-91B2-CC2CC70E6A8D}"/>
              </a:ext>
            </a:extLst>
          </p:cNvPr>
          <p:cNvSpPr txBox="1"/>
          <p:nvPr/>
        </p:nvSpPr>
        <p:spPr>
          <a:xfrm>
            <a:off x="4131368" y="571531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TfR1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CE6F3D99-23BD-4F49-A3D2-528833F29DD2}"/>
              </a:ext>
            </a:extLst>
          </p:cNvPr>
          <p:cNvSpPr/>
          <p:nvPr/>
        </p:nvSpPr>
        <p:spPr>
          <a:xfrm>
            <a:off x="1687399" y="1502111"/>
            <a:ext cx="1574275" cy="1791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69BCAAA8-58F9-4FBE-A14A-E35EC3E5DE29}"/>
              </a:ext>
            </a:extLst>
          </p:cNvPr>
          <p:cNvSpPr/>
          <p:nvPr/>
        </p:nvSpPr>
        <p:spPr>
          <a:xfrm>
            <a:off x="5242399" y="1762661"/>
            <a:ext cx="1574275" cy="1791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C9E805E1-1A4D-49D6-AB88-A0EE11083D9E}"/>
              </a:ext>
            </a:extLst>
          </p:cNvPr>
          <p:cNvSpPr/>
          <p:nvPr/>
        </p:nvSpPr>
        <p:spPr>
          <a:xfrm>
            <a:off x="9155490" y="1898223"/>
            <a:ext cx="1574275" cy="1833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B545AEB-C384-490C-A833-CEC33FEBCE59}"/>
              </a:ext>
            </a:extLst>
          </p:cNvPr>
          <p:cNvSpPr txBox="1"/>
          <p:nvPr/>
        </p:nvSpPr>
        <p:spPr>
          <a:xfrm>
            <a:off x="249730" y="3137344"/>
            <a:ext cx="88761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We</a:t>
            </a:r>
            <a:r>
              <a:rPr kumimoji="1" lang="en-US" altLang="ja-JP" sz="1400" b="1" dirty="0"/>
              <a:t> </a:t>
            </a:r>
            <a:r>
              <a:rPr lang="en-US" altLang="ja-JP" sz="1400" b="1" dirty="0"/>
              <a:t>u</a:t>
            </a:r>
            <a:r>
              <a:rPr kumimoji="1" lang="en-US" altLang="ja-JP" sz="1400" b="1" dirty="0"/>
              <a:t>nintentionally omitted blots of both ends because of some lack in signals in FPN1 immunoblot.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DC9C8BC-51DE-487E-B50D-882831DB2658}"/>
              </a:ext>
            </a:extLst>
          </p:cNvPr>
          <p:cNvSpPr txBox="1"/>
          <p:nvPr/>
        </p:nvSpPr>
        <p:spPr>
          <a:xfrm>
            <a:off x="196350" y="2276430"/>
            <a:ext cx="2390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ngle band at 62kDa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28ACD87-31B1-4F2E-8C07-747811AB46C1}"/>
              </a:ext>
            </a:extLst>
          </p:cNvPr>
          <p:cNvSpPr txBox="1"/>
          <p:nvPr/>
        </p:nvSpPr>
        <p:spPr>
          <a:xfrm>
            <a:off x="4140794" y="2116981"/>
            <a:ext cx="2390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ngle band at 90kDa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83">
            <a:extLst>
              <a:ext uri="{FF2B5EF4-FFF2-40B4-BE49-F238E27FC236}">
                <a16:creationId xmlns:a16="http://schemas.microsoft.com/office/drawing/2014/main" id="{EC459AA2-D45E-47EF-A120-CBE50E73B111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lum bright="-13000" contrast="18000"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1" t="1121" r="770" b="1689"/>
          <a:stretch/>
        </p:blipFill>
        <p:spPr>
          <a:xfrm>
            <a:off x="197988" y="4052976"/>
            <a:ext cx="3219800" cy="2730881"/>
          </a:xfrm>
          <a:prstGeom prst="rect">
            <a:avLst/>
          </a:prstGeom>
          <a:ln>
            <a:noFill/>
          </a:ln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8E2CF3DE-E1E2-440F-A5B9-227E8B06722D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7518" y="4106453"/>
            <a:ext cx="2263140" cy="2329434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F7C73E0-35DC-4F92-8688-FFDE2353AE18}"/>
              </a:ext>
            </a:extLst>
          </p:cNvPr>
          <p:cNvSpPr txBox="1"/>
          <p:nvPr/>
        </p:nvSpPr>
        <p:spPr>
          <a:xfrm>
            <a:off x="191136" y="3701343"/>
            <a:ext cx="23070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IP:FPN1 / </a:t>
            </a:r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B:Ubiquitin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C15B6EF-48BA-4ABA-9C26-E27428586B9D}"/>
              </a:ext>
            </a:extLst>
          </p:cNvPr>
          <p:cNvSpPr txBox="1"/>
          <p:nvPr/>
        </p:nvSpPr>
        <p:spPr>
          <a:xfrm>
            <a:off x="3882852" y="3788618"/>
            <a:ext cx="19399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IP:FPN1 / IB:FPN1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01938338-11DA-4BE3-9F28-F50A7D3B43F5}"/>
              </a:ext>
            </a:extLst>
          </p:cNvPr>
          <p:cNvSpPr/>
          <p:nvPr/>
        </p:nvSpPr>
        <p:spPr>
          <a:xfrm>
            <a:off x="1323297" y="4910342"/>
            <a:ext cx="1395167" cy="9962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0F28E1CF-E62E-429E-83FF-18A0DC2DD47F}"/>
              </a:ext>
            </a:extLst>
          </p:cNvPr>
          <p:cNvSpPr/>
          <p:nvPr/>
        </p:nvSpPr>
        <p:spPr>
          <a:xfrm>
            <a:off x="4424763" y="4943757"/>
            <a:ext cx="1338606" cy="4719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15792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4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suya Sato</dc:creator>
  <cp:lastModifiedBy>Hossein Ardehali</cp:lastModifiedBy>
  <cp:revision>6</cp:revision>
  <dcterms:created xsi:type="dcterms:W3CDTF">2021-09-01T13:45:54Z</dcterms:created>
  <dcterms:modified xsi:type="dcterms:W3CDTF">2021-11-11T02:42:21Z</dcterms:modified>
</cp:coreProperties>
</file>